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627813" cy="82296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38DAD-4A44-410C-9DAE-0BB8135747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331560" y="475848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C1885-FB07-4F18-BB4F-FACC7CC2FF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5"/>
          <p:cNvSpPr>
            <a:spLocks noGrp="1"/>
          </p:cNvSpPr>
          <p:nvPr>
            <p:ph/>
          </p:nvPr>
        </p:nvSpPr>
        <p:spPr>
          <a:xfrm>
            <a:off x="338760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9168C6-752E-44E1-BAFB-2432973228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234828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4"/>
          <p:cNvSpPr>
            <a:spLocks noGrp="1"/>
          </p:cNvSpPr>
          <p:nvPr>
            <p:ph/>
          </p:nvPr>
        </p:nvSpPr>
        <p:spPr>
          <a:xfrm>
            <a:off x="4365000" y="192096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5"/>
          <p:cNvSpPr>
            <a:spLocks noGrp="1"/>
          </p:cNvSpPr>
          <p:nvPr>
            <p:ph/>
          </p:nvPr>
        </p:nvSpPr>
        <p:spPr>
          <a:xfrm>
            <a:off x="33156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6"/>
          <p:cNvSpPr>
            <a:spLocks noGrp="1"/>
          </p:cNvSpPr>
          <p:nvPr>
            <p:ph/>
          </p:nvPr>
        </p:nvSpPr>
        <p:spPr>
          <a:xfrm>
            <a:off x="234828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" name="PlaceHolder 7"/>
          <p:cNvSpPr>
            <a:spLocks noGrp="1"/>
          </p:cNvSpPr>
          <p:nvPr>
            <p:ph/>
          </p:nvPr>
        </p:nvSpPr>
        <p:spPr>
          <a:xfrm>
            <a:off x="4365000" y="4758480"/>
            <a:ext cx="192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76B80-88C5-463C-A049-342ABA3DAD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subTitle"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3D7CD3-F94C-47CB-A11E-D166F5A3B9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9395B-1257-4578-A5E1-8B3B9389E5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4F4AD-D770-4517-9512-47574101E0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EF4985-8C1D-4E29-B210-CC15B59090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subTitle"/>
          </p:nvPr>
        </p:nvSpPr>
        <p:spPr>
          <a:xfrm>
            <a:off x="331560" y="330120"/>
            <a:ext cx="596412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DF297-CF6E-4A17-9827-883E11CFF1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26D02-A6EF-4B8C-9A3B-0C25081F11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3387600" y="475848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EF024B-E530-4F69-B3DC-AD6C1434DD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33156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3387600" y="1920960"/>
            <a:ext cx="291024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331560" y="4758480"/>
            <a:ext cx="5964120" cy="259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AA59F-2D1E-4646-845B-286769E2C4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31560" y="330120"/>
            <a:ext cx="596412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31560" y="1920960"/>
            <a:ext cx="5964120" cy="543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31560" y="7495920"/>
            <a:ext cx="154620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63680" y="7495920"/>
            <a:ext cx="210024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749480" y="7495920"/>
            <a:ext cx="1546200" cy="57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448FD8-7F57-4C69-91E6-E8958AA1565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Base" hidden="1"/>
          <p:cNvSpPr/>
          <p:nvPr/>
        </p:nvSpPr>
        <p:spPr>
          <a:xfrm>
            <a:off x="1104840" y="2643120"/>
            <a:ext cx="4417920" cy="29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138600" y="155520"/>
            <a:ext cx="2777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able S2.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RPT used in clinical performance study.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08000" y="442800"/>
          <a:ext cx="6408720" cy="1335240"/>
        </p:xfrm>
        <a:graphic>
          <a:graphicData uri="http://schemas.openxmlformats.org/drawingml/2006/table">
            <a:tbl>
              <a:tblPr/>
              <a:tblGrid>
                <a:gridCol w="436680"/>
                <a:gridCol w="447480"/>
                <a:gridCol w="444600"/>
                <a:gridCol w="447480"/>
                <a:gridCol w="444600"/>
                <a:gridCol w="449280"/>
                <a:gridCol w="446040"/>
                <a:gridCol w="444600"/>
                <a:gridCol w="447480"/>
                <a:gridCol w="446400"/>
                <a:gridCol w="446040"/>
                <a:gridCol w="446040"/>
                <a:gridCol w="530280"/>
                <a:gridCol w="531720"/>
              </a:tblGrid>
              <a:tr h="335520"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C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S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2V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13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600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542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545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545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047L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1047R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520"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x10</a:t>
                      </a:r>
                      <a:r>
                        <a:rPr b="0" lang="en-US" sz="7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520"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8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0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5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0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80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9400"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P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min)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1368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0" rIns="90000" tIns="46800" bIns="46800" anchor="ctr">
                      <a:noAutofit/>
                    </a:bodyPr>
                    <a:p>
                      <a:pPr algn="ctr">
                        <a:spcBef>
                          <a:spcPts val="176"/>
                        </a:spcBef>
                        <a:tabLst>
                          <a:tab algn="l" pos="0"/>
                          <a:tab algn="l" pos="3828960"/>
                          <a:tab algn="l" pos="7658280"/>
                        </a:tabLst>
                      </a:pPr>
                      <a:r>
                        <a:rPr b="0" lang="en-US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0" marR="90000">
                    <a:lnL w="5760">
                      <a:solidFill>
                        <a:srgbClr val="000000"/>
                      </a:solidFill>
                    </a:lnL>
                    <a:lnR w="1368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142560" y="1811160"/>
            <a:ext cx="178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PT = Ratio Positive Threshol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20T10:28:37Z</dcterms:created>
  <dc:creator>LS</dc:creator>
  <dc:description/>
  <dc:language>en-US</dc:language>
  <cp:lastModifiedBy>LS</cp:lastModifiedBy>
  <dcterms:modified xsi:type="dcterms:W3CDTF">2013-04-04T00:58:01Z</dcterms:modified>
  <cp:revision>50</cp:revision>
  <dc:subject/>
  <dc:title>スライド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596899766</vt:r8>
  </property>
  <property fmtid="{D5CDD505-2E9C-101B-9397-08002B2CF9AE}" pid="3" name="_AuthorEmail">
    <vt:lpwstr>masahiko.amano@toppan.co.jp</vt:lpwstr>
  </property>
  <property fmtid="{D5CDD505-2E9C-101B-9397-08002B2CF9AE}" pid="4" name="_AuthorEmailDisplayName">
    <vt:lpwstr>天野雅彦</vt:lpwstr>
  </property>
  <property fmtid="{D5CDD505-2E9C-101B-9397-08002B2CF9AE}" pid="5" name="_EmailSubject">
    <vt:lpwstr>論文legends</vt:lpwstr>
  </property>
  <property fmtid="{D5CDD505-2E9C-101B-9397-08002B2CF9AE}" pid="6" name="_ReviewingToolsShownOnce">
    <vt:lpwstr/>
  </property>
</Properties>
</file>